
<file path=[Content_Types].xml><?xml version="1.0" encoding="utf-8"?>
<Types xmlns="http://schemas.openxmlformats.org/package/2006/content-types">
  <Default Extension="xml" ContentType="application/xml"/>
  <Default Extension="mov" ContentType="video/quicktime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254" r:id="rId1"/>
  </p:sldMasterIdLst>
  <p:notesMasterIdLst>
    <p:notesMasterId r:id="rId6"/>
  </p:notesMasterIdLst>
  <p:sldIdLst>
    <p:sldId id="328" r:id="rId2"/>
    <p:sldId id="333" r:id="rId3"/>
    <p:sldId id="329" r:id="rId4"/>
    <p:sldId id="341" r:id="rId5"/>
  </p:sldIdLst>
  <p:sldSz cx="12192000" cy="6858000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SimSun" charset="0"/>
        <a:cs typeface="SimSun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79">
          <p15:clr>
            <a:srgbClr val="A4A3A4"/>
          </p15:clr>
        </p15:guide>
        <p15:guide id="2" pos="38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2DFF1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43" autoAdjust="0"/>
    <p:restoredTop sz="94637" autoAdjust="0"/>
  </p:normalViewPr>
  <p:slideViewPr>
    <p:cSldViewPr snapToGrid="0">
      <p:cViewPr>
        <p:scale>
          <a:sx n="150" d="100"/>
          <a:sy n="150" d="100"/>
        </p:scale>
        <p:origin x="1352" y="1560"/>
      </p:cViewPr>
      <p:guideLst>
        <p:guide orient="horz" pos="2179"/>
        <p:guide pos="384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kumimoji="1" sz="1200">
                <a:latin typeface="Arial" panose="020B0604020202020204" pitchFamily="34" charset="0"/>
                <a:ea typeface="SimSun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kumimoji="1" sz="1200"/>
            </a:lvl1pPr>
          </a:lstStyle>
          <a:p>
            <a:pPr>
              <a:defRPr/>
            </a:pPr>
            <a:fld id="{1F3322E0-01F9-604D-AA75-EC37DFC94102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kumimoji="1" sz="1200">
                <a:latin typeface="Arial" panose="020B0604020202020204" pitchFamily="34" charset="0"/>
                <a:ea typeface="SimSun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kumimoji="1" sz="1200"/>
            </a:lvl1pPr>
          </a:lstStyle>
          <a:p>
            <a:pPr>
              <a:defRPr/>
            </a:pPr>
            <a:fld id="{C8B7FE3B-82DD-3947-AA9E-EC00D7FB113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9346945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SimSun" pitchFamily="2" charset="-122"/>
        <a:cs typeface="SimSun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SimSun" pitchFamily="2" charset="-122"/>
        <a:cs typeface="SimSun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SimSun" pitchFamily="2" charset="-122"/>
        <a:cs typeface="SimSun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SimSun" pitchFamily="2" charset="-122"/>
        <a:cs typeface="SimSun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SimSun" pitchFamily="2" charset="-122"/>
        <a:cs typeface="SimSun" charset="0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3" y="2130464"/>
            <a:ext cx="103632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23" y="3886202"/>
            <a:ext cx="8534401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57835FFA-8F90-F940-B51A-E51BEC301905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B723C24A-E253-CC42-9D92-7EF8D3BB610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4318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22FE5470-F460-9E41-8318-C3CFD8D5A7DA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8D48A591-6DC5-D740-924D-EEF1E63248D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0957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3" y="274679"/>
            <a:ext cx="27432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26" y="274679"/>
            <a:ext cx="8026399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FF269851-3689-954E-BB41-1A5D7DD283A8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EB1B2306-2B8C-914B-A216-27DE884E18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38733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92334266-5C14-A349-A00B-5AB406D69CEC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438D2627-CFB9-634C-AFFE-4C6FF09F415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16350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7" y="440694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7" y="2906722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1E6F43AE-0BE1-184A-B4C4-45AB73782ABD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82C92C6F-8F86-CD45-A9F1-75CACD0AF3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46909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6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6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958E1767-4E3B-E04C-93DF-E6075DE4BEA3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C92D13C7-5EB2-4E44-B565-6C935593A4A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27239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3" y="1535114"/>
            <a:ext cx="538691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3" y="2174875"/>
            <a:ext cx="538691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96" y="1535114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96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24480B9C-5502-A04E-B03D-1E4204981FA1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976C3C19-C58D-5E4C-B481-FAC6301987B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1658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B7BFCB27-4285-DD4C-A9CD-755DE5499B48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0A72AC05-C85B-1440-AB64-2F17DDA9AE3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45275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5970D024-7D2F-FE4C-A393-7BBE2CD0E7EA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BF52FFD0-B121-1846-9DC9-3759614C02E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8970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9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3" y="1435104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814ED2B4-0616-5C48-81E3-3238CB42079E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25D9C741-793A-DB40-BCDF-22033FD667F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95676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9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9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0240D7D2-3FBD-8045-8A73-70ACF3C9A92D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defTabSz="914400">
              <a:defRPr kumimoji="0"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defTabSz="914400">
              <a:defRPr kumimoji="0">
                <a:latin typeface="Arial" charset="0"/>
                <a:ea typeface="SimSun" charset="0"/>
                <a:cs typeface="SimSun" charset="0"/>
              </a:defRPr>
            </a:lvl1pPr>
          </a:lstStyle>
          <a:p>
            <a:pPr>
              <a:defRPr/>
            </a:pPr>
            <a:fld id="{4CA8D955-E4F8-CF40-951C-6EC46007009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1694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defTabSz="457200" eaLnBrk="1" hangingPunct="1">
              <a:defRPr kumimoji="1" sz="1200">
                <a:solidFill>
                  <a:srgbClr val="898989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fld id="{3A43FB2F-3382-254E-A9D4-FDD27BDB2BAA}" type="datetimeFigureOut">
              <a:rPr lang="ja-JP" altLang="en-US"/>
              <a:pPr>
                <a:defRPr/>
              </a:pPr>
              <a:t>2016/5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eaLnBrk="1" hangingPunct="1">
              <a:defRPr kumimoji="1" sz="1200">
                <a:solidFill>
                  <a:srgbClr val="898989"/>
                </a:solidFill>
                <a:latin typeface="Calibri" pitchFamily="34" charset="0"/>
                <a:ea typeface="SimSun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defTabSz="457200" eaLnBrk="1" hangingPunct="1">
              <a:defRPr kumimoji="1" sz="1200">
                <a:solidFill>
                  <a:srgbClr val="898989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fld id="{3F562A60-F0BD-524E-8E32-85C8E7A6EE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7586" r:id="rId1"/>
    <p:sldLayoutId id="2147487587" r:id="rId2"/>
    <p:sldLayoutId id="2147487588" r:id="rId3"/>
    <p:sldLayoutId id="2147487589" r:id="rId4"/>
    <p:sldLayoutId id="2147487590" r:id="rId5"/>
    <p:sldLayoutId id="2147487591" r:id="rId6"/>
    <p:sldLayoutId id="2147487592" r:id="rId7"/>
    <p:sldLayoutId id="2147487593" r:id="rId8"/>
    <p:sldLayoutId id="2147487594" r:id="rId9"/>
    <p:sldLayoutId id="2147487595" r:id="rId10"/>
    <p:sldLayoutId id="2147487596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SimSun" pitchFamily="2" charset="-122"/>
          <a:cs typeface="SimSun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  <a:cs typeface="SimSun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  <a:cs typeface="SimSun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  <a:cs typeface="SimSun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  <a:cs typeface="SimSun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SimSun" pitchFamily="2" charset="-122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SimSun" pitchFamily="2" charset="-122"/>
          <a:cs typeface="SimSun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SimSun" pitchFamily="2" charset="-122"/>
          <a:cs typeface="SimSun" charset="0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SimSun" pitchFamily="2" charset="-122"/>
          <a:cs typeface="SimSun" charset="0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SimSun" pitchFamily="2" charset="-122"/>
          <a:cs typeface="SimSun" charset="0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SimSun" pitchFamily="2" charset="-122"/>
          <a:cs typeface="SimSun" charset="0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4" Type="http://schemas.openxmlformats.org/officeDocument/2006/relationships/video" Target="../media/media2.mov"/><Relationship Id="rId5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7" Type="http://schemas.openxmlformats.org/officeDocument/2006/relationships/image" Target="../media/image2.png"/><Relationship Id="rId1" Type="http://schemas.microsoft.com/office/2007/relationships/media" Target="../media/media1.mov"/><Relationship Id="rId2" Type="http://schemas.openxmlformats.org/officeDocument/2006/relationships/video" Target="../media/media1.mov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4.mov"/><Relationship Id="rId4" Type="http://schemas.openxmlformats.org/officeDocument/2006/relationships/video" Target="../media/media4.mov"/><Relationship Id="rId5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1" Type="http://schemas.microsoft.com/office/2007/relationships/media" Target="../media/media3.mov"/><Relationship Id="rId2" Type="http://schemas.openxmlformats.org/officeDocument/2006/relationships/video" Target="../media/media3.mov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6.mov"/><Relationship Id="rId4" Type="http://schemas.openxmlformats.org/officeDocument/2006/relationships/video" Target="../media/media6.mov"/><Relationship Id="rId5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microsoft.com/office/2007/relationships/media" Target="../media/media5.mov"/><Relationship Id="rId2" Type="http://schemas.openxmlformats.org/officeDocument/2006/relationships/video" Target="../media/media5.mov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8.mov"/><Relationship Id="rId4" Type="http://schemas.openxmlformats.org/officeDocument/2006/relationships/video" Target="../media/media8.mov"/><Relationship Id="rId5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1" Type="http://schemas.microsoft.com/office/2007/relationships/media" Target="../media/media7.mov"/><Relationship Id="rId2" Type="http://schemas.openxmlformats.org/officeDocument/2006/relationships/video" Target="../media/media7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SN_04_R3D_VOL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15925" y="813329"/>
            <a:ext cx="5298738" cy="5604933"/>
          </a:xfrm>
          <a:prstGeom prst="rect">
            <a:avLst/>
          </a:prstGeom>
        </p:spPr>
      </p:pic>
      <p:pic>
        <p:nvPicPr>
          <p:cNvPr id="22" name="SN_12_R3D_VOL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148387" y="813329"/>
            <a:ext cx="5298738" cy="5604933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3801534" y="1007534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35000" y="1820334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499600" y="1007534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1439333" y="2175933"/>
            <a:ext cx="1608667" cy="1371601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9770532" y="1964266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H="1">
            <a:off x="8771467" y="2370666"/>
            <a:ext cx="1253067" cy="1354667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7162799" y="5867399"/>
            <a:ext cx="1377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>
                <a:solidFill>
                  <a:schemeClr val="bg1"/>
                </a:solidFill>
              </a:rPr>
              <a:t>Folicle</a:t>
            </a:r>
            <a:r>
              <a:rPr kumimoji="1" lang="en-US" altLang="ja-JP" dirty="0" smtClean="0">
                <a:solidFill>
                  <a:schemeClr val="bg1"/>
                </a:solidFill>
              </a:rPr>
              <a:t> cell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cxnSp>
        <p:nvCxnSpPr>
          <p:cNvPr id="24" name="直線コネクタ 23"/>
          <p:cNvCxnSpPr/>
          <p:nvPr/>
        </p:nvCxnSpPr>
        <p:spPr>
          <a:xfrm>
            <a:off x="8576733" y="6045200"/>
            <a:ext cx="922868" cy="17780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>
            <a:spLocks noChangeArrowheads="1"/>
          </p:cNvSpPr>
          <p:nvPr/>
        </p:nvSpPr>
        <p:spPr bwMode="auto">
          <a:xfrm>
            <a:off x="0" y="61892"/>
            <a:ext cx="105494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9pPr>
          </a:lstStyle>
          <a:p>
            <a:r>
              <a:rPr kumimoji="0" lang="en-US" altLang="ja-JP" sz="1400" b="1" dirty="0">
                <a:latin typeface="Helvetica" charset="0"/>
                <a:cs typeface="Helvetica" charset="0"/>
              </a:rPr>
              <a:t>Supplementary Movie 1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. Surrounding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Nucleolus (SN)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oocyte</a:t>
            </a:r>
            <a:endParaRPr lang="ja-JP" altLang="en-US" sz="1400" b="1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36636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1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1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NSN05_R3D_VOL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83658" y="973662"/>
            <a:ext cx="5458821" cy="5774267"/>
          </a:xfrm>
          <a:prstGeom prst="rect">
            <a:avLst/>
          </a:prstGeom>
        </p:spPr>
      </p:pic>
      <p:pic>
        <p:nvPicPr>
          <p:cNvPr id="3" name="NSN06_R3D_VOL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156325" y="973661"/>
            <a:ext cx="5458821" cy="5774268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3801534" y="897463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35000" y="1710263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499600" y="897463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1109133" y="2074329"/>
            <a:ext cx="1583267" cy="1718733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9770532" y="1854195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H="1">
            <a:off x="9194800" y="2260595"/>
            <a:ext cx="829735" cy="2175934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>
            <a:stCxn id="10" idx="2"/>
          </p:cNvCxnSpPr>
          <p:nvPr/>
        </p:nvCxnSpPr>
        <p:spPr>
          <a:xfrm>
            <a:off x="1234139" y="2079595"/>
            <a:ext cx="2660528" cy="1713467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>
            <a:spLocks noChangeArrowheads="1"/>
          </p:cNvSpPr>
          <p:nvPr/>
        </p:nvSpPr>
        <p:spPr bwMode="auto">
          <a:xfrm>
            <a:off x="0" y="61892"/>
            <a:ext cx="105494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9pPr>
          </a:lstStyle>
          <a:p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Supplementary Movie 2. Non-Surrounding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Nucleolus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(NSN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)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oocyte</a:t>
            </a:r>
            <a:endParaRPr lang="ja-JP" altLang="en-US" sz="1400" b="1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35979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50219GV-rZ4_CREST_mH2B11_R3D_VOL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50355" y="973666"/>
            <a:ext cx="5299238" cy="5605463"/>
          </a:xfrm>
          <a:prstGeom prst="rect">
            <a:avLst/>
          </a:prstGeom>
        </p:spPr>
      </p:pic>
      <p:pic>
        <p:nvPicPr>
          <p:cNvPr id="5" name="150219GV-rZ4_CREST_mH2B10_R3D_VOL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054218" y="956203"/>
            <a:ext cx="5299238" cy="5605463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677334" y="1007534"/>
            <a:ext cx="3143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008000"/>
                </a:solidFill>
              </a:rPr>
              <a:t>Centromere (CREST)</a:t>
            </a:r>
            <a:endParaRPr kumimoji="1" lang="ja-JP" altLang="en-US" sz="2400" dirty="0">
              <a:solidFill>
                <a:srgbClr val="008000"/>
              </a:solidFill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801534" y="1007534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35000" y="1820334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499600" y="1007534"/>
            <a:ext cx="13989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FF0000"/>
                </a:solidFill>
              </a:rPr>
              <a:t>ZSCAN4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231468" y="1007534"/>
            <a:ext cx="3143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solidFill>
                  <a:srgbClr val="008000"/>
                </a:solidFill>
              </a:rPr>
              <a:t>Centromere (CREST)</a:t>
            </a:r>
            <a:endParaRPr kumimoji="1" lang="ja-JP" altLang="en-US" sz="2400" dirty="0">
              <a:solidFill>
                <a:srgbClr val="008000"/>
              </a:solidFill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1439333" y="2175933"/>
            <a:ext cx="1608667" cy="1371601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10041466" y="2108200"/>
            <a:ext cx="11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Nucleolus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 flipH="1">
            <a:off x="9347200" y="2472266"/>
            <a:ext cx="1253067" cy="1354667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>
            <a:spLocks noChangeArrowheads="1"/>
          </p:cNvSpPr>
          <p:nvPr/>
        </p:nvSpPr>
        <p:spPr bwMode="auto">
          <a:xfrm>
            <a:off x="0" y="61892"/>
            <a:ext cx="105494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9pPr>
          </a:lstStyle>
          <a:p>
            <a:r>
              <a:rPr kumimoji="0" lang="en-US" altLang="ja-JP" sz="1400" b="1" dirty="0">
                <a:latin typeface="Helvetica" charset="0"/>
                <a:cs typeface="Helvetica" charset="0"/>
              </a:rPr>
              <a:t>Supplementary Movie 3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. Surrounding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Nucleolus (SN)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oocyte</a:t>
            </a:r>
            <a:endParaRPr lang="ja-JP" altLang="en-US" sz="1400" b="1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27320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151125GVrZ4FITCmS2_05_R3D_VOL.mo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413422" y="1032933"/>
            <a:ext cx="5363712" cy="5673662"/>
          </a:xfrm>
          <a:prstGeom prst="rect">
            <a:avLst/>
          </a:prstGeom>
        </p:spPr>
      </p:pic>
      <p:pic>
        <p:nvPicPr>
          <p:cNvPr id="6" name="151125GVrZ4FITCmS2_06_R3D_VOL.mov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84198" y="1009933"/>
            <a:ext cx="5435601" cy="5749705"/>
          </a:xfrm>
          <a:prstGeom prst="rect">
            <a:avLst/>
          </a:prstGeom>
        </p:spPr>
      </p:pic>
      <p:sp>
        <p:nvSpPr>
          <p:cNvPr id="10" name="正方形/長方形 9"/>
          <p:cNvSpPr/>
          <p:nvPr/>
        </p:nvSpPr>
        <p:spPr>
          <a:xfrm>
            <a:off x="619126" y="1047743"/>
            <a:ext cx="11588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800" b="1" dirty="0" smtClean="0">
                <a:solidFill>
                  <a:srgbClr val="FFFFFF"/>
                </a:solidFill>
                <a:latin typeface="Helvetica"/>
                <a:cs typeface="Helvetica"/>
              </a:rPr>
              <a:t>NSN</a:t>
            </a:r>
            <a:endParaRPr lang="en-US" altLang="ja-JP" sz="2800" b="1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6400799" y="1039282"/>
            <a:ext cx="127000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800" b="1" dirty="0" smtClean="0">
                <a:solidFill>
                  <a:srgbClr val="FFFFFF"/>
                </a:solidFill>
                <a:latin typeface="Helvetica"/>
                <a:cs typeface="Helvetica"/>
              </a:rPr>
              <a:t>SN</a:t>
            </a:r>
            <a:endParaRPr lang="en-US" altLang="ja-JP" sz="2800" b="1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619126" y="5535947"/>
            <a:ext cx="52482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400" b="1" dirty="0" smtClean="0">
                <a:solidFill>
                  <a:srgbClr val="FF0000"/>
                </a:solidFill>
                <a:latin typeface="Helvetica"/>
                <a:cs typeface="Helvetica"/>
              </a:rPr>
              <a:t>ZSCAN4</a:t>
            </a:r>
            <a:endParaRPr lang="en-US" altLang="ja-JP" sz="2400" b="1" dirty="0">
              <a:solidFill>
                <a:schemeClr val="bg1"/>
              </a:solidFill>
              <a:latin typeface="Helvetica"/>
              <a:cs typeface="Helvetica"/>
            </a:endParaRPr>
          </a:p>
          <a:p>
            <a:pPr>
              <a:defRPr/>
            </a:pPr>
            <a:r>
              <a:rPr lang="en-US" altLang="ja-JP" sz="2400" b="1" dirty="0" smtClean="0">
                <a:solidFill>
                  <a:srgbClr val="2DFF10"/>
                </a:solidFill>
                <a:latin typeface="Helvetica"/>
                <a:cs typeface="Helvetica"/>
              </a:rPr>
              <a:t>pol2 </a:t>
            </a:r>
            <a:r>
              <a:rPr lang="en-US" altLang="ja-JP" sz="2400" b="1" dirty="0" smtClean="0">
                <a:solidFill>
                  <a:srgbClr val="2DFF10"/>
                </a:solidFill>
                <a:latin typeface="Helvetica"/>
                <a:cs typeface="Helvetica"/>
              </a:rPr>
              <a:t>ser2P</a:t>
            </a:r>
            <a:endParaRPr lang="en-US" altLang="ja-JP" sz="24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6444193" y="5476676"/>
            <a:ext cx="5273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400" b="1" dirty="0" smtClean="0">
                <a:solidFill>
                  <a:srgbClr val="FF0000"/>
                </a:solidFill>
                <a:latin typeface="Helvetica"/>
                <a:cs typeface="Helvetica"/>
              </a:rPr>
              <a:t>ZSCAN4</a:t>
            </a:r>
            <a:endParaRPr lang="en-US" altLang="ja-JP" sz="2400" b="1" dirty="0">
              <a:solidFill>
                <a:schemeClr val="bg1"/>
              </a:solidFill>
              <a:latin typeface="Helvetica"/>
              <a:cs typeface="Helvetica"/>
            </a:endParaRPr>
          </a:p>
          <a:p>
            <a:pPr>
              <a:defRPr/>
            </a:pPr>
            <a:r>
              <a:rPr lang="en-US" altLang="ja-JP" sz="2400" b="1" dirty="0">
                <a:solidFill>
                  <a:srgbClr val="2DFF10"/>
                </a:solidFill>
                <a:latin typeface="Helvetica"/>
                <a:cs typeface="Helvetica"/>
              </a:rPr>
              <a:t>pol2 </a:t>
            </a:r>
            <a:r>
              <a:rPr lang="en-US" altLang="ja-JP" sz="2400" b="1" dirty="0" smtClean="0">
                <a:solidFill>
                  <a:srgbClr val="2DFF10"/>
                </a:solidFill>
                <a:latin typeface="Helvetica"/>
                <a:cs typeface="Helvetica"/>
              </a:rPr>
              <a:t>ser2P</a:t>
            </a:r>
            <a:endParaRPr lang="en-US" altLang="ja-JP" sz="2400" b="1" dirty="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>
            <a:spLocks noChangeArrowheads="1"/>
          </p:cNvSpPr>
          <p:nvPr/>
        </p:nvSpPr>
        <p:spPr bwMode="auto">
          <a:xfrm>
            <a:off x="0" y="155026"/>
            <a:ext cx="1054946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SimSun" charset="0"/>
                <a:cs typeface="SimSun" charset="0"/>
              </a:defRPr>
            </a:lvl9pPr>
          </a:lstStyle>
          <a:p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Supplementary Movie 4. Non-Surrounding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Nucleolus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(NSN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) </a:t>
            </a:r>
            <a:r>
              <a:rPr kumimoji="0" lang="en-US" altLang="ja-JP" sz="1400" b="1" dirty="0" smtClean="0">
                <a:latin typeface="Helvetica" charset="0"/>
                <a:cs typeface="Helvetica" charset="0"/>
              </a:rPr>
              <a:t>oocyte</a:t>
            </a:r>
            <a:endParaRPr lang="ja-JP" altLang="en-US" sz="1400" b="1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75953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3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" fill="hold">
                      <p:stCondLst>
                        <p:cond delay="0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8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  <p:bldLst>
      <p:bldP spid="11" grpId="0"/>
    </p:bld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rgbClr val="FF0000"/>
          </a:solidFill>
        </a:ln>
        <a:effectLst/>
      </a:spPr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75</TotalTime>
  <Pages>0</Pages>
  <Words>70</Words>
  <Characters>0</Characters>
  <Application>Microsoft Macintosh PowerPoint</Application>
  <DocSecurity>0</DocSecurity>
  <PresentationFormat>ワイド画面</PresentationFormat>
  <Lines>0</Lines>
  <Paragraphs>25</Paragraphs>
  <Slides>4</Slides>
  <Notes>0</Notes>
  <HiddenSlides>0</HiddenSlides>
  <MMClips>8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Calibri</vt:lpstr>
      <vt:lpstr>Helvetica</vt:lpstr>
      <vt:lpstr>ＭＳ Ｐゴシック</vt:lpstr>
      <vt:lpstr>SimSun</vt:lpstr>
      <vt:lpstr>Arial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CharactersWithSpaces>0</CharactersWithSpaces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/17/2014 – 3/22/2014</dc:title>
  <dc:subject/>
  <dc:creator>sysmed</dc:creator>
  <cp:keywords/>
  <dc:description/>
  <cp:lastModifiedBy>Kei-ichiro Ishiguro</cp:lastModifiedBy>
  <cp:revision>345</cp:revision>
  <cp:lastPrinted>2015-11-25T10:33:56Z</cp:lastPrinted>
  <dcterms:created xsi:type="dcterms:W3CDTF">2014-03-21T21:02:00Z</dcterms:created>
  <dcterms:modified xsi:type="dcterms:W3CDTF">2016-05-09T04:55:43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8.1.0.3185</vt:lpwstr>
  </property>
</Properties>
</file>